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8DEAC61E-BF0C-E370-BE28-6D582524AE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45C0FE55-7BA3-AB7A-6643-4D9AFA34CE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DF57FCEC-D6C6-B1F1-0388-90981050C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41C8D325-3B09-946F-F3B1-080FD7BF0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46D53657-C0B8-E53D-099D-2FA5434C3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53236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5E52FE22-02A4-000A-D5A9-1B0DBE7EC9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7E7F033E-873B-67B2-6016-529096C5D8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962238F4-7605-9029-D625-76430DFE7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EA08D5F9-F6A1-266E-2130-89ED0E97F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B031977D-B006-7978-590B-568B6AFDF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509141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8577FA66-7959-AA93-A518-CC6E267F87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0CF547D7-A34D-98A2-4957-7B0191CEEB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AE18EE73-5044-4E9B-22A4-D8D3FBA47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4AAB8EB2-C6E6-CBA2-5947-77EEAFC5B5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AC6ED47E-BF49-E49A-F4F4-06C7B1508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34709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054661C-6C07-9476-2740-4957EE0285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21E83FAF-CA61-7131-D477-4C5016BACF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576BC541-A021-621D-4D69-556F309EE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446D4B3A-0233-72F4-2D9F-F4810FBDA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C5E8754E-41BB-D811-D287-DC1692FC4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68460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AE5E3D1-C8E4-C2B3-E484-224A6A23F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29C263C2-9451-595E-6634-EB68C47F0D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FC6AA7D4-6AE3-5DF6-E56D-6E6652AF5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C99C3252-D775-B47F-5E4B-8A6FECE14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6D43DFFA-3BE6-02AC-C4E2-DD463075A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71309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3661BE4B-EEE6-15C5-7652-1F569F098A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9F764AE0-D426-C0BC-1659-D6024733E9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56A9809B-D6BE-6CC9-94F6-C07C532894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50166138-B1C5-9485-E90D-515E0312C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92D53167-1784-FD4E-A650-3C597A2F1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0FF945ED-EC06-A6EC-ECD5-6B7F49082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22551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DFE37E74-90ED-7CD3-6F29-DC5F365DB8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DCD70699-A3F5-28FE-74A3-72EAC0D50D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ABBDC782-6A2D-2661-3A6E-F195946F54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5BB28469-D56A-9D24-26A4-9852BEAE54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FEB284D9-CA68-E48F-8CDE-731C4762A9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50967685-2103-3061-1258-D8C64A5DD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27A7D96C-903D-84D0-710C-02A2C86F8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EA123CD0-1DCA-9EA3-DFBF-E48644D93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969276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C32FC287-C813-3A68-62AF-D8C7311E3F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9B8E8FC9-C8BA-7BDC-0700-C5EB2AA8DE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3B1E23F8-B180-E7DC-2A36-957F5C382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5E2C1F95-F37F-FE2F-845D-308F36E72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39543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E87DC8E6-EBC9-3C1D-7962-570A97BAD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7D8470DC-F9C1-F30B-68D5-034A3CAD34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C954A717-8EB1-A78D-8524-DD545CC807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78600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91CB64E-7EBF-FA1E-CA47-BFE43FCB79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CC33E1C3-72E2-9BAD-C04E-94D4B390F7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AE705DC7-2537-73CC-CD5E-39E6189DEF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8CFFE9E8-51DD-1B17-83B6-D9F911F52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D72BA7CA-B9CB-3798-9D0B-AD0597D357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7E962B97-426E-4C39-1316-3764D496C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357334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94150615-5E6F-C2D5-7858-C8A48C71D5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20E6627D-03CD-4307-99AC-38D4174123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79D5C8CB-FECF-BF7E-18A3-1D669D3440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4FAFBB01-E549-68E0-3891-18197818A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1DF95C23-62A1-E75C-206C-3536B09C5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DDFDAD91-5AD8-4B78-FF0C-5C4761BC9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81452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8C9BFDCF-342D-D44D-965E-A8D1ABD9A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831539A1-3D38-7FE3-FCE2-F33BED286C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2BC07EFF-5268-960B-F8E3-5DE9521B69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308943-33F7-478A-92AD-B7D012E26CB7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E51D399C-3871-CE78-3B53-A51F33F61B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4F3388F6-F41E-6742-50AE-E783292B1C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D688BD-B161-41C1-8E12-FA3BFAF348A5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867581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รูปภาพ 1">
            <a:extLst>
              <a:ext uri="{FF2B5EF4-FFF2-40B4-BE49-F238E27FC236}">
                <a16:creationId xmlns:a16="http://schemas.microsoft.com/office/drawing/2014/main" id="{48099017-006D-9A35-A486-A7E6E86B59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7711" y="1335564"/>
            <a:ext cx="8738480" cy="3253689"/>
          </a:xfrm>
          <a:prstGeom prst="rect">
            <a:avLst/>
          </a:prstGeom>
        </p:spPr>
      </p:pic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667D1AAB-22EF-A7E0-3D8B-0B5D69415EAD}"/>
              </a:ext>
            </a:extLst>
          </p:cNvPr>
          <p:cNvSpPr txBox="1"/>
          <p:nvPr/>
        </p:nvSpPr>
        <p:spPr>
          <a:xfrm>
            <a:off x="1654474" y="4398260"/>
            <a:ext cx="10094703" cy="4778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Figure S14. MS/MS spectrum of kaempferol-7-O-glucoside exhibiting a similar fragmentation pattern consistent with flavonoid glycoside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1100460891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แบบจอกว้า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9:16:06Z</dcterms:created>
  <dcterms:modified xsi:type="dcterms:W3CDTF">2026-02-22T09:16:59Z</dcterms:modified>
</cp:coreProperties>
</file>